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2" d="100"/>
          <a:sy n="82" d="100"/>
        </p:scale>
        <p:origin x="691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0F15E6-7C59-495F-865F-4232CE919F5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69F89D1-00AB-4151-9C9B-D08B9C3C4B2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37F5E0E-5842-4D28-BCA4-E80F9A21E9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226E80-D333-4FCB-9BD0-B9F1782014C1}" type="datetimeFigureOut">
              <a:rPr lang="en-US" smtClean="0"/>
              <a:t>11/1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40ECC66-DEC0-447F-A79A-942D3995AC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14BC40C-C5B2-4771-8F9A-9F77FCC9C6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6B202F-810F-4BAD-B826-2C1CD46246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8201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3AA389-8CFE-4FD1-8C59-6A33B9AF4C9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497C375-854A-4758-B83B-F26E8026E09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73C1039-1695-4F2C-9EFC-5D969F6A9A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226E80-D333-4FCB-9BD0-B9F1782014C1}" type="datetimeFigureOut">
              <a:rPr lang="en-US" smtClean="0"/>
              <a:t>11/1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1B82E56-3061-4920-8FDD-50EEEC2F03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3B23B9A-84AB-4351-9908-6747FCC13E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6B202F-810F-4BAD-B826-2C1CD46246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35714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B4E7CAE-236E-4D3D-956F-E3CEA0220FE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9851102-D876-4549-B9D3-55C59AC7D2A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FA8B692-4CAD-4401-B183-397B530500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226E80-D333-4FCB-9BD0-B9F1782014C1}" type="datetimeFigureOut">
              <a:rPr lang="en-US" smtClean="0"/>
              <a:t>11/1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2159D54-5E3A-47D6-A480-07C99954D2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5EA444D-A89C-40DE-A8CE-9DD4FCA21F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6B202F-810F-4BAD-B826-2C1CD46246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73956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38A9B52-5CB2-4CDB-B3AC-451D134D55C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3B9FF88-3162-44FB-B8F0-0A168C57716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8A41B5A-3AFB-44AE-8049-571BC2FFD7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226E80-D333-4FCB-9BD0-B9F1782014C1}" type="datetimeFigureOut">
              <a:rPr lang="en-US" smtClean="0"/>
              <a:t>11/1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6B09702-A55C-41A3-B37F-2412604F1B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E79EF5D-C263-4643-890B-68B8476314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6B202F-810F-4BAD-B826-2C1CD46246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51542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2B5072-D5E0-4782-A1C1-D35D2B4A9B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B8BDA6F-E0D8-4C2E-89FB-EE1A137296B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C062F8C-B75D-4A6A-85C9-25BB91C83E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226E80-D333-4FCB-9BD0-B9F1782014C1}" type="datetimeFigureOut">
              <a:rPr lang="en-US" smtClean="0"/>
              <a:t>11/1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973021E-6CAF-43BE-9DA9-48DF0899EE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EC7F541-C85A-453E-BDB6-42550BC174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6B202F-810F-4BAD-B826-2C1CD46246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69761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77B6B1-101D-4F45-8E4D-B3C51732A60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57B2E22-E2A9-424A-83B1-111BFF26802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FAE8C82-4A19-4DDE-828D-15459F038BC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51E09DD-6BFA-478F-9126-24CCDE7385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226E80-D333-4FCB-9BD0-B9F1782014C1}" type="datetimeFigureOut">
              <a:rPr lang="en-US" smtClean="0"/>
              <a:t>11/18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9CC8B99-C888-4A4D-B181-B28BF659BC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ED0622C-1F68-440F-874E-4CFF52ED95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6B202F-810F-4BAD-B826-2C1CD46246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21505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72BD69-9F91-4DCF-A6E8-D22A2E7073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F313731-EDEB-4A83-9D04-61ACE20F008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9F596F3-3EBA-448F-A703-32324EC94BE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28BCDC0-CDEA-428F-B2E5-003DB457765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589E449-8453-436A-A5E4-CB6FD653756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E212042-35EF-4EEA-9A48-33B4BE6341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226E80-D333-4FCB-9BD0-B9F1782014C1}" type="datetimeFigureOut">
              <a:rPr lang="en-US" smtClean="0"/>
              <a:t>11/18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8A01513-DA73-493F-A0C0-0E6DE842B2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FDC1D6B-F2EA-4986-B06A-B47895F159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6B202F-810F-4BAD-B826-2C1CD46246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68347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ECFF57-5DEF-4377-A3FD-6BC37FBBFBF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87F26F7-D183-440A-A817-FEA0DC2739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226E80-D333-4FCB-9BD0-B9F1782014C1}" type="datetimeFigureOut">
              <a:rPr lang="en-US" smtClean="0"/>
              <a:t>11/18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FA72524-55AA-4AFF-9B2F-BE16A2E42E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578EF61-1DD7-411D-84E6-537EC45154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6B202F-810F-4BAD-B826-2C1CD46246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17929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6CE66C7-4F96-406F-804A-9DA507A942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226E80-D333-4FCB-9BD0-B9F1782014C1}" type="datetimeFigureOut">
              <a:rPr lang="en-US" smtClean="0"/>
              <a:t>11/18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6208615-E13C-40A8-993D-DC0DA4E5A9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6001562-CF22-4A03-B62B-5900281783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6B202F-810F-4BAD-B826-2C1CD46246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81217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EC29A96-00DC-4E0F-9CA5-208F178E55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20FC690-0D86-4BBB-B67A-3C28C9DE5C5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E1F2D81-8EE9-4EFC-A0E5-5392B41117E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D69182A-36D9-4888-8156-AA89F6B435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226E80-D333-4FCB-9BD0-B9F1782014C1}" type="datetimeFigureOut">
              <a:rPr lang="en-US" smtClean="0"/>
              <a:t>11/18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7FE8BB2-2B06-4149-8BDE-B1F9DCC2C0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512C444-12C9-4F3D-A74D-A8911EE303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6B202F-810F-4BAD-B826-2C1CD46246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99366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B2F95A-79D6-4DAB-B832-B7EC74B27C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ED3DB25-D51C-4995-ACF9-4C922F18868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6C446CD-9069-4395-899A-CC1AD714DF5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B9AEE64-F858-4479-ACC2-76271AAA1E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226E80-D333-4FCB-9BD0-B9F1782014C1}" type="datetimeFigureOut">
              <a:rPr lang="en-US" smtClean="0"/>
              <a:t>11/18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0C6F4B4-ADAC-42CA-838C-473D922107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E8EEB2A-B6FC-4D7A-AB94-185EF0CB55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6B202F-810F-4BAD-B826-2C1CD46246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35444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38EA32F-3CE5-4850-9323-CE54BD7209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13E698A-A4A8-4A33-9667-CDFF680C5DB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7DAD532-250E-400D-8817-C7DD601BAD9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226E80-D333-4FCB-9BD0-B9F1782014C1}" type="datetimeFigureOut">
              <a:rPr lang="en-US" smtClean="0"/>
              <a:t>11/1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2BADFBA-8B3E-4C5F-83C2-3E23873E2A0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88F254F-63FB-46BD-BF43-647C2A54B8A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6B202F-810F-4BAD-B826-2C1CD46246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69286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png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>
            <a:extLst>
              <a:ext uri="{FF2B5EF4-FFF2-40B4-BE49-F238E27FC236}">
                <a16:creationId xmlns:a16="http://schemas.microsoft.com/office/drawing/2014/main" id="{D17692E7-930D-42D8-B126-374DDC7D5A88}"/>
              </a:ext>
            </a:extLst>
          </p:cNvPr>
          <p:cNvGrpSpPr/>
          <p:nvPr/>
        </p:nvGrpSpPr>
        <p:grpSpPr>
          <a:xfrm>
            <a:off x="6135315" y="1037210"/>
            <a:ext cx="5698156" cy="3404346"/>
            <a:chOff x="7994719" y="423425"/>
            <a:chExt cx="3972960" cy="2915447"/>
          </a:xfrm>
        </p:grpSpPr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43463B4D-EF91-42F3-8210-BE1A9C886485}"/>
                </a:ext>
              </a:extLst>
            </p:cNvPr>
            <p:cNvSpPr txBox="1"/>
            <p:nvPr/>
          </p:nvSpPr>
          <p:spPr>
            <a:xfrm>
              <a:off x="7994719" y="651168"/>
              <a:ext cx="348452" cy="31629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5DBFB84D-48A5-4B0E-A19C-DE3DD8CD5E5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8384405" y="683108"/>
              <a:ext cx="3583274" cy="2458559"/>
            </a:xfrm>
            <a:prstGeom prst="rect">
              <a:avLst/>
            </a:prstGeom>
          </p:spPr>
        </p:pic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D3CE7B63-734D-46D2-BEA8-EB932412BB23}"/>
                </a:ext>
              </a:extLst>
            </p:cNvPr>
            <p:cNvSpPr txBox="1"/>
            <p:nvPr/>
          </p:nvSpPr>
          <p:spPr>
            <a:xfrm>
              <a:off x="9823507" y="3061873"/>
              <a:ext cx="9144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effectLst/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GS (µM)</a:t>
              </a:r>
              <a:endParaRPr lang="en-GB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72163DE8-D5A0-4DCD-A352-397F9C6D1C8E}"/>
                </a:ext>
              </a:extLst>
            </p:cNvPr>
            <p:cNvSpPr txBox="1"/>
            <p:nvPr/>
          </p:nvSpPr>
          <p:spPr>
            <a:xfrm>
              <a:off x="9794512" y="423425"/>
              <a:ext cx="113832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RPMI 8226</a:t>
              </a:r>
              <a:endParaRPr lang="en-GB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07070695-C0D3-40E6-B752-6ADEF6AA6F68}"/>
                </a:ext>
              </a:extLst>
            </p:cNvPr>
            <p:cNvSpPr txBox="1"/>
            <p:nvPr/>
          </p:nvSpPr>
          <p:spPr>
            <a:xfrm rot="16200000">
              <a:off x="7468452" y="1453688"/>
              <a:ext cx="155490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Cell viability (%)</a:t>
              </a:r>
              <a:endParaRPr lang="en-GB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51C41F83-E87D-4180-99C8-898D37919E1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hqprint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sharpenSoften amount="5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9527822" y="758795"/>
              <a:ext cx="2232000" cy="297721"/>
            </a:xfrm>
            <a:prstGeom prst="rect">
              <a:avLst/>
            </a:prstGeom>
          </p:spPr>
        </p:pic>
      </p:grpSp>
      <p:grpSp>
        <p:nvGrpSpPr>
          <p:cNvPr id="21" name="Group 20">
            <a:extLst>
              <a:ext uri="{FF2B5EF4-FFF2-40B4-BE49-F238E27FC236}">
                <a16:creationId xmlns:a16="http://schemas.microsoft.com/office/drawing/2014/main" id="{BB6DD8CF-8035-4C5E-9BEB-373D65C5161F}"/>
              </a:ext>
            </a:extLst>
          </p:cNvPr>
          <p:cNvGrpSpPr/>
          <p:nvPr/>
        </p:nvGrpSpPr>
        <p:grpSpPr>
          <a:xfrm>
            <a:off x="572337" y="1145653"/>
            <a:ext cx="5233066" cy="3344050"/>
            <a:chOff x="577694" y="1728464"/>
            <a:chExt cx="4008414" cy="2808843"/>
          </a:xfrm>
        </p:grpSpPr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F8388553-C681-4829-9AAA-BE149178F531}"/>
                </a:ext>
              </a:extLst>
            </p:cNvPr>
            <p:cNvSpPr txBox="1"/>
            <p:nvPr/>
          </p:nvSpPr>
          <p:spPr>
            <a:xfrm>
              <a:off x="577694" y="1885764"/>
              <a:ext cx="269148" cy="310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id="{331639EB-2F65-4A93-9484-5CA220FACA4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826644" y="2027211"/>
              <a:ext cx="3759464" cy="2272939"/>
            </a:xfrm>
            <a:prstGeom prst="rect">
              <a:avLst/>
            </a:prstGeom>
          </p:spPr>
        </p:pic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52BBF295-3C82-4D34-BBF6-5B18C3A0083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hqprint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sharpenSoften amount="5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2237909" y="2038185"/>
              <a:ext cx="2232000" cy="297721"/>
            </a:xfrm>
            <a:prstGeom prst="rect">
              <a:avLst/>
            </a:prstGeom>
          </p:spPr>
        </p:pic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E62BB256-675F-468D-8E4D-522DCCFC8DFB}"/>
                </a:ext>
              </a:extLst>
            </p:cNvPr>
            <p:cNvSpPr txBox="1"/>
            <p:nvPr/>
          </p:nvSpPr>
          <p:spPr>
            <a:xfrm>
              <a:off x="2390304" y="1728464"/>
              <a:ext cx="9144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MM1S</a:t>
              </a:r>
              <a:endParaRPr lang="en-GB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3F0F64AA-B021-4711-8C4A-62C8936C4F10}"/>
                </a:ext>
              </a:extLst>
            </p:cNvPr>
            <p:cNvSpPr txBox="1"/>
            <p:nvPr/>
          </p:nvSpPr>
          <p:spPr>
            <a:xfrm rot="16200000">
              <a:off x="34656" y="2883010"/>
              <a:ext cx="155490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Cell viability (%)</a:t>
              </a:r>
              <a:endParaRPr lang="en-GB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5773CB56-0B4D-4048-85E0-D70ED13F6892}"/>
                </a:ext>
              </a:extLst>
            </p:cNvPr>
            <p:cNvSpPr txBox="1"/>
            <p:nvPr/>
          </p:nvSpPr>
          <p:spPr>
            <a:xfrm>
              <a:off x="2460159" y="4260308"/>
              <a:ext cx="9144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effectLst/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GS (µM)</a:t>
              </a:r>
              <a:endParaRPr lang="en-GB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2" name="TextBox 21">
            <a:extLst>
              <a:ext uri="{FF2B5EF4-FFF2-40B4-BE49-F238E27FC236}">
                <a16:creationId xmlns:a16="http://schemas.microsoft.com/office/drawing/2014/main" id="{00E04656-CADB-43AF-896C-CD0B10CD9A62}"/>
              </a:ext>
            </a:extLst>
          </p:cNvPr>
          <p:cNvSpPr txBox="1"/>
          <p:nvPr/>
        </p:nvSpPr>
        <p:spPr>
          <a:xfrm>
            <a:off x="9686394" y="83807"/>
            <a:ext cx="257955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 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7342106A-5B1A-4F11-83E3-2CB49AC89A70}"/>
              </a:ext>
            </a:extLst>
          </p:cNvPr>
          <p:cNvSpPr/>
          <p:nvPr/>
        </p:nvSpPr>
        <p:spPr>
          <a:xfrm>
            <a:off x="526577" y="4728102"/>
            <a:ext cx="11138846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ea typeface="Times New Roman" panose="02020603050405020304" pitchFamily="18" charset="0"/>
              </a:rPr>
              <a:t>Supplementary </a:t>
            </a:r>
            <a:r>
              <a:rPr lang="en-US" b="1">
                <a:latin typeface="Arial" panose="020B0604020202020204" pitchFamily="34" charset="0"/>
                <a:ea typeface="Times New Roman" panose="02020603050405020304" pitchFamily="18" charset="0"/>
              </a:rPr>
              <a:t>Figure S1</a:t>
            </a:r>
            <a:r>
              <a:rPr lang="en-US" b="1" dirty="0">
                <a:latin typeface="Arial" panose="020B0604020202020204" pitchFamily="34" charset="0"/>
                <a:ea typeface="Times New Roman" panose="02020603050405020304" pitchFamily="18" charset="0"/>
              </a:rPr>
              <a:t>. </a:t>
            </a:r>
            <a:r>
              <a:rPr lang="en-US" dirty="0">
                <a:latin typeface="Arial" panose="020B0604020202020204" pitchFamily="34" charset="0"/>
                <a:ea typeface="Times New Roman" panose="02020603050405020304" pitchFamily="18" charset="0"/>
              </a:rPr>
              <a:t>Anti-proliferative</a:t>
            </a:r>
            <a:r>
              <a:rPr lang="en-US" b="1" dirty="0"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lang="en-US" dirty="0">
                <a:latin typeface="Arial" panose="020B0604020202020204" pitchFamily="34" charset="0"/>
                <a:ea typeface="Times New Roman" panose="02020603050405020304" pitchFamily="18" charset="0"/>
              </a:rPr>
              <a:t>effects of GS on MM cells. GS inhibits the viability of (</a:t>
            </a:r>
            <a:r>
              <a:rPr lang="en-US" b="1" dirty="0">
                <a:latin typeface="Arial" panose="020B0604020202020204" pitchFamily="34" charset="0"/>
                <a:ea typeface="Times New Roman" panose="02020603050405020304" pitchFamily="18" charset="0"/>
              </a:rPr>
              <a:t>A</a:t>
            </a:r>
            <a:r>
              <a:rPr lang="en-US" dirty="0">
                <a:latin typeface="Arial" panose="020B0604020202020204" pitchFamily="34" charset="0"/>
                <a:ea typeface="Times New Roman" panose="02020603050405020304" pitchFamily="18" charset="0"/>
              </a:rPr>
              <a:t>) MM.1S (</a:t>
            </a:r>
            <a:r>
              <a:rPr lang="en-US" b="1" dirty="0">
                <a:latin typeface="Arial" panose="020B0604020202020204" pitchFamily="34" charset="0"/>
                <a:ea typeface="Times New Roman" panose="02020603050405020304" pitchFamily="18" charset="0"/>
              </a:rPr>
              <a:t>B</a:t>
            </a:r>
            <a:r>
              <a:rPr lang="en-US" dirty="0">
                <a:latin typeface="Arial" panose="020B0604020202020204" pitchFamily="34" charset="0"/>
                <a:ea typeface="Times New Roman" panose="02020603050405020304" pitchFamily="18" charset="0"/>
              </a:rPr>
              <a:t>) RPMI 8226 in a concentration-dependent manner after treatment with  5, 10, 25, and 50 µM of GS for 48 h. The graphs display the mean ± SD of three independent experiments with replicates. *p&lt;0.05, **p</a:t>
            </a:r>
            <a:r>
              <a:rPr lang="en-US">
                <a:latin typeface="Arial" panose="020B0604020202020204" pitchFamily="34" charset="0"/>
                <a:ea typeface="Times New Roman" panose="02020603050405020304" pitchFamily="18" charset="0"/>
              </a:rPr>
              <a:t>&lt;0.01</a:t>
            </a:r>
            <a:r>
              <a:rPr lang="en-US" dirty="0">
                <a:latin typeface="Arial" panose="020B0604020202020204" pitchFamily="34" charset="0"/>
                <a:ea typeface="Times New Roman" panose="02020603050405020304" pitchFamily="18" charset="0"/>
              </a:rPr>
              <a:t>.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641108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</TotalTime>
  <Words>96</Words>
  <Application>Microsoft Office PowerPoint</Application>
  <PresentationFormat>Widescreen</PresentationFormat>
  <Paragraphs>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Cambria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ahab Uddin Khan</dc:creator>
  <cp:lastModifiedBy>MDPI</cp:lastModifiedBy>
  <cp:revision>4</cp:revision>
  <dcterms:created xsi:type="dcterms:W3CDTF">2022-10-27T22:06:21Z</dcterms:created>
  <dcterms:modified xsi:type="dcterms:W3CDTF">2022-11-18T07:08:4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573f5887-035d-4765-8d10-97aaac8deb4a_Enabled">
    <vt:lpwstr>true</vt:lpwstr>
  </property>
  <property fmtid="{D5CDD505-2E9C-101B-9397-08002B2CF9AE}" pid="3" name="MSIP_Label_573f5887-035d-4765-8d10-97aaac8deb4a_SetDate">
    <vt:lpwstr>2022-10-27T22:06:21Z</vt:lpwstr>
  </property>
  <property fmtid="{D5CDD505-2E9C-101B-9397-08002B2CF9AE}" pid="4" name="MSIP_Label_573f5887-035d-4765-8d10-97aaac8deb4a_Method">
    <vt:lpwstr>Standard</vt:lpwstr>
  </property>
  <property fmtid="{D5CDD505-2E9C-101B-9397-08002B2CF9AE}" pid="5" name="MSIP_Label_573f5887-035d-4765-8d10-97aaac8deb4a_Name">
    <vt:lpwstr>Public</vt:lpwstr>
  </property>
  <property fmtid="{D5CDD505-2E9C-101B-9397-08002B2CF9AE}" pid="6" name="MSIP_Label_573f5887-035d-4765-8d10-97aaac8deb4a_SiteId">
    <vt:lpwstr>f08ae827-76a0-4eda-8325-df208f3835ab</vt:lpwstr>
  </property>
  <property fmtid="{D5CDD505-2E9C-101B-9397-08002B2CF9AE}" pid="7" name="MSIP_Label_573f5887-035d-4765-8d10-97aaac8deb4a_ActionId">
    <vt:lpwstr>c50c1488-3ac8-4799-98ea-303c5be388fe</vt:lpwstr>
  </property>
  <property fmtid="{D5CDD505-2E9C-101B-9397-08002B2CF9AE}" pid="8" name="MSIP_Label_573f5887-035d-4765-8d10-97aaac8deb4a_ContentBits">
    <vt:lpwstr>0</vt:lpwstr>
  </property>
</Properties>
</file>